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9144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232" autoAdjust="0"/>
    <p:restoredTop sz="94660"/>
  </p:normalViewPr>
  <p:slideViewPr>
    <p:cSldViewPr snapToGrid="0">
      <p:cViewPr varScale="1">
        <p:scale>
          <a:sx n="77" d="100"/>
          <a:sy n="77" d="100"/>
        </p:scale>
        <p:origin x="-690" y="-102"/>
      </p:cViewPr>
      <p:guideLst>
        <p:guide orient="horz" pos="10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8CB7CB-FEBB-4334-8522-FA0D37ABD8ED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57DF26-5A18-4996-9CD9-7A05E92A9A2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691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58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17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9200" y="366188"/>
            <a:ext cx="274320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600" y="366188"/>
            <a:ext cx="802640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6074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634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3875621"/>
            <a:ext cx="10363200" cy="20002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3493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7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57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3" y="2046817"/>
            <a:ext cx="5386917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3" y="2899833"/>
            <a:ext cx="5386917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70" y="2046817"/>
            <a:ext cx="5389033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70" y="2899833"/>
            <a:ext cx="5389033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5952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5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5596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364070"/>
            <a:ext cx="6815668" cy="7804151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913470"/>
            <a:ext cx="4011084" cy="6254751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65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6400803"/>
            <a:ext cx="7315200" cy="755651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7156454"/>
            <a:ext cx="7315200" cy="1073149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453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2133604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600" y="8475137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7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10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1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7973009"/>
              </p:ext>
            </p:extLst>
          </p:nvPr>
        </p:nvGraphicFramePr>
        <p:xfrm>
          <a:off x="284831" y="1019472"/>
          <a:ext cx="11622338" cy="99385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708156"/>
                <a:gridCol w="857956"/>
                <a:gridCol w="587022"/>
                <a:gridCol w="713458"/>
                <a:gridCol w="3164555"/>
                <a:gridCol w="3164555"/>
                <a:gridCol w="1426636"/>
              </a:tblGrid>
              <a:tr h="331285">
                <a:tc>
                  <a:txBody>
                    <a:bodyPr/>
                    <a:lstStyle/>
                    <a:p>
                      <a:pPr algn="l" fontAlgn="ctr"/>
                      <a:endParaRPr lang="ko-KR" altLang="en-US" sz="1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on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US" sz="1800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ns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sens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ign too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12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F43-SUPT4H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</a:t>
                      </a:r>
                      <a:endParaRPr lang="ko-KR" altLang="en-US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</a:t>
                      </a:r>
                      <a:endParaRPr lang="ko-KR" altLang="en-US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ACAGCGCAACAGACUAU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AGUCUGUUGCGCUGUC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u="none" strike="noStrike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hamacon</a:t>
                      </a:r>
                      <a:r>
                        <a:rPr lang="en-US" altLang="ko-KR" sz="1600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Thermo)</a:t>
                      </a:r>
                      <a:endParaRPr lang="ko-KR" altLang="en-US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312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F43-SUPT4H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ko-KR" altLang="en-US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</a:t>
                      </a:r>
                      <a:endParaRPr lang="ko-KR" altLang="en-US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ACAGACUAUAGACCAG 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GGUCUAUAGUCUGUUGC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820" marR="12820" marT="12820" marB="0" anchor="ctr"/>
                </a:tc>
                <a:tc vMerge="1"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 dirty="0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pSp>
        <p:nvGrpSpPr>
          <p:cNvPr id="15" name="그룹 14"/>
          <p:cNvGrpSpPr/>
          <p:nvPr/>
        </p:nvGrpSpPr>
        <p:grpSpPr>
          <a:xfrm>
            <a:off x="284831" y="2349664"/>
            <a:ext cx="11622338" cy="5854080"/>
            <a:chOff x="284831" y="2349664"/>
            <a:chExt cx="11622338" cy="5854080"/>
          </a:xfrm>
        </p:grpSpPr>
        <p:grpSp>
          <p:nvGrpSpPr>
            <p:cNvPr id="10" name="그룹 9"/>
            <p:cNvGrpSpPr/>
            <p:nvPr/>
          </p:nvGrpSpPr>
          <p:grpSpPr>
            <a:xfrm>
              <a:off x="284831" y="2715833"/>
              <a:ext cx="11622338" cy="5487911"/>
              <a:chOff x="126282" y="2926480"/>
              <a:chExt cx="6537565" cy="3086950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 rotWithShape="1">
              <a:blip r:embed="rId2"/>
              <a:srcRect r="7196" b="47415"/>
              <a:stretch/>
            </p:blipFill>
            <p:spPr>
              <a:xfrm>
                <a:off x="126282" y="2926480"/>
                <a:ext cx="6537565" cy="3086950"/>
              </a:xfrm>
              <a:prstGeom prst="rect">
                <a:avLst/>
              </a:prstGeom>
            </p:spPr>
          </p:pic>
          <p:cxnSp>
            <p:nvCxnSpPr>
              <p:cNvPr id="4" name="직선 연결선 3"/>
              <p:cNvCxnSpPr/>
              <p:nvPr/>
            </p:nvCxnSpPr>
            <p:spPr bwMode="auto">
              <a:xfrm flipV="1">
                <a:off x="4212516" y="3182620"/>
                <a:ext cx="778584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직선 연결선 4"/>
              <p:cNvCxnSpPr/>
              <p:nvPr/>
            </p:nvCxnSpPr>
            <p:spPr bwMode="auto">
              <a:xfrm>
                <a:off x="4587166" y="3241796"/>
                <a:ext cx="648000" cy="0"/>
              </a:xfrm>
              <a:prstGeom prst="line">
                <a:avLst/>
              </a:prstGeom>
              <a:ln w="28575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3" name="직선 연결선 12"/>
            <p:cNvCxnSpPr/>
            <p:nvPr/>
          </p:nvCxnSpPr>
          <p:spPr>
            <a:xfrm>
              <a:off x="8530541" y="2673753"/>
              <a:ext cx="0" cy="216000"/>
            </a:xfrm>
            <a:prstGeom prst="line">
              <a:avLst/>
            </a:prstGeom>
            <a:ln w="28575">
              <a:solidFill>
                <a:srgbClr val="FF0000"/>
              </a:solidFill>
              <a:headEnd type="oval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7187878" y="2349664"/>
              <a:ext cx="28126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sion junction</a:t>
              </a:r>
              <a:endParaRPr lang="ko-KR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직사각형 15"/>
          <p:cNvSpPr/>
          <p:nvPr/>
        </p:nvSpPr>
        <p:spPr>
          <a:xfrm>
            <a:off x="284831" y="8385417"/>
            <a:ext cx="1162233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901700" indent="-901700"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altLang="ko-K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F43-SUPT4H1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sion transcript variant 1 targeted siRNA candidates. siRNA candidates were designed to including fusion junction. Red arrow was fusion junction, and each under bars were siRNA candidates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97875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0</TotalTime>
  <Words>62</Words>
  <Application>Microsoft Office PowerPoint</Application>
  <PresentationFormat>Custom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 Author</dc:creator>
  <cp:lastModifiedBy>Real, Francis Frank</cp:lastModifiedBy>
  <cp:revision>55</cp:revision>
  <dcterms:created xsi:type="dcterms:W3CDTF">2015-06-22T23:51:12Z</dcterms:created>
  <dcterms:modified xsi:type="dcterms:W3CDTF">2016-07-26T03:43:00Z</dcterms:modified>
</cp:coreProperties>
</file>